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ABB07-0975-40C4-B8C9-AE4F5D75BD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68430-E0C6-494B-9068-515C83D691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88C4C-8B7E-4545-BF8E-C6690D887C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C0CA1-C363-4B35-91B8-2D25143329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8EFFE-3DBE-45F8-B1F7-6C3EFFD6E2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3663F-9DD7-4947-8001-41CB4A197F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94F7C-B86C-4CD4-BBBF-23FAC5D9A9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5DBB1-BF40-4049-BB31-B59DE4480A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B60B4-76A9-4372-BE25-151BF5B493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73339-CCB3-4B9B-8F02-2C44CEC6BA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9E5C3-1A40-4F66-A2A8-967683EF21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A23BC-70B0-498B-9ED5-29EAB1199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2D307D-78C8-4A02-A771-37C2804E445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"/>
          <p:cNvGrpSpPr/>
          <p:nvPr/>
        </p:nvGrpSpPr>
        <p:grpSpPr>
          <a:xfrm>
            <a:off x="2819520" y="1008000"/>
            <a:ext cx="2655720" cy="1778040"/>
            <a:chOff x="2819520" y="1008000"/>
            <a:chExt cx="2655720" cy="1778040"/>
          </a:xfrm>
        </p:grpSpPr>
        <p:pic>
          <p:nvPicPr>
            <p:cNvPr id="42" name="Picture 16" descr=""/>
            <p:cNvPicPr/>
            <p:nvPr/>
          </p:nvPicPr>
          <p:blipFill>
            <a:blip r:embed="rId1"/>
            <a:srcRect l="0" t="27909" r="0" b="10907"/>
            <a:stretch/>
          </p:blipFill>
          <p:spPr>
            <a:xfrm>
              <a:off x="2819520" y="1008000"/>
              <a:ext cx="2655720" cy="177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Rectangle 17"/>
            <p:cNvSpPr/>
            <p:nvPr/>
          </p:nvSpPr>
          <p:spPr>
            <a:xfrm>
              <a:off x="3529440" y="1536120"/>
              <a:ext cx="298800" cy="759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18"/>
            <p:cNvSpPr/>
            <p:nvPr/>
          </p:nvSpPr>
          <p:spPr>
            <a:xfrm>
              <a:off x="3976560" y="1608480"/>
              <a:ext cx="298800" cy="694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9"/>
            <p:cNvSpPr/>
            <p:nvPr/>
          </p:nvSpPr>
          <p:spPr>
            <a:xfrm>
              <a:off x="4431600" y="2134440"/>
              <a:ext cx="302040" cy="165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46" name="Picture 11" descr=""/>
          <p:cNvPicPr/>
          <p:nvPr/>
        </p:nvPicPr>
        <p:blipFill>
          <a:blip r:embed="rId2"/>
          <a:srcRect l="0" t="18634" r="0" b="25457"/>
          <a:stretch/>
        </p:blipFill>
        <p:spPr>
          <a:xfrm>
            <a:off x="2819520" y="3781440"/>
            <a:ext cx="3617640" cy="216216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7"/>
          <p:cNvSpPr/>
          <p:nvPr/>
        </p:nvSpPr>
        <p:spPr>
          <a:xfrm>
            <a:off x="2514960" y="436680"/>
            <a:ext cx="432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. Cell-Free Infection of MT-4 By Virus Produced In 293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2496960" y="3160800"/>
            <a:ext cx="359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.  Cell-Cell Infection of MT-4 By 293T Donor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"/>
          <p:cNvSpPr/>
          <p:nvPr/>
        </p:nvSpPr>
        <p:spPr>
          <a:xfrm>
            <a:off x="6888240" y="6321600"/>
            <a:ext cx="128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Watanabe et 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"/>
          <p:cNvSpPr/>
          <p:nvPr/>
        </p:nvSpPr>
        <p:spPr>
          <a:xfrm>
            <a:off x="6862320" y="6013440"/>
            <a:ext cx="188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l Figure S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12T18:44:06Z</dcterms:created>
  <dc:creator>Carol</dc:creator>
  <dc:description/>
  <dc:language>en-US</dc:language>
  <cp:lastModifiedBy>bonnie</cp:lastModifiedBy>
  <dcterms:modified xsi:type="dcterms:W3CDTF">2016-08-22T01:33:18Z</dcterms:modified>
  <cp:revision>614</cp:revision>
  <dc:subject/>
  <dc:title>PowerPoint Presentation</dc:title>
</cp:coreProperties>
</file>